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6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104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098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895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782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179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809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604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30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248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5190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A6C52-971D-4461-8C58-8DAB4DF81F00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58D2F-15E6-4B64-BCD3-7627E8390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7328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2368562"/>
              </p:ext>
            </p:extLst>
          </p:nvPr>
        </p:nvGraphicFramePr>
        <p:xfrm>
          <a:off x="482600" y="1803877"/>
          <a:ext cx="10762344" cy="1928971"/>
        </p:xfrm>
        <a:graphic>
          <a:graphicData uri="http://schemas.openxmlformats.org/drawingml/2006/table">
            <a:tbl>
              <a:tblPr/>
              <a:tblGrid>
                <a:gridCol w="983632"/>
                <a:gridCol w="2800968"/>
                <a:gridCol w="2111828"/>
                <a:gridCol w="2155372"/>
                <a:gridCol w="2710544"/>
              </a:tblGrid>
              <a:tr h="9937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ateri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Photosynthetic </a:t>
                      </a:r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ate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μ</a:t>
                      </a:r>
                      <a:r>
                        <a:rPr lang="en-US" sz="16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ol</a:t>
                      </a:r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O</a:t>
                      </a:r>
                      <a:r>
                        <a:rPr lang="en-US" sz="16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pt-BR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</a:t>
                      </a:r>
                      <a:r>
                        <a:rPr lang="pt-BR" altLang="zh-CN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−2</a:t>
                      </a:r>
                      <a:r>
                        <a:rPr lang="pt-BR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s</a:t>
                      </a:r>
                      <a:r>
                        <a:rPr lang="pt-BR" altLang="zh-CN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−1</a:t>
                      </a:r>
                      <a:endParaRPr lang="pt-BR" altLang="zh-CN" sz="16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ntercellular CO</a:t>
                      </a:r>
                      <a:r>
                        <a:rPr lang="en-GB" sz="16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GB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oncentration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μ</a:t>
                      </a:r>
                      <a:r>
                        <a:rPr lang="en-GB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ol</a:t>
                      </a:r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CO</a:t>
                      </a:r>
                      <a:r>
                        <a:rPr lang="en-GB" sz="16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pt-BR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</a:t>
                      </a:r>
                      <a:r>
                        <a:rPr lang="pt-BR" altLang="zh-CN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−2</a:t>
                      </a:r>
                      <a:r>
                        <a:rPr lang="pt-BR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s</a:t>
                      </a:r>
                      <a:r>
                        <a:rPr lang="pt-BR" altLang="zh-CN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−1</a:t>
                      </a:r>
                      <a:endParaRPr lang="pt-BR" altLang="zh-CN" sz="16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tomatal Conductance</a:t>
                      </a:r>
                    </a:p>
                    <a:p>
                      <a:pPr algn="ctr" fontAlgn="b"/>
                      <a:r>
                        <a:rPr lang="pt-B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ol </a:t>
                      </a:r>
                      <a:r>
                        <a:rPr lang="pt-B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</a:t>
                      </a:r>
                      <a:r>
                        <a:rPr lang="pt-BR" sz="16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pt-B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O m</a:t>
                      </a:r>
                      <a:r>
                        <a:rPr lang="pt-BR" sz="16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−2</a:t>
                      </a:r>
                      <a:r>
                        <a:rPr lang="pt-B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s</a:t>
                      </a:r>
                      <a:r>
                        <a:rPr lang="pt-BR" sz="16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−1</a:t>
                      </a:r>
                      <a:endParaRPr lang="pt-B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ranspiration Rate</a:t>
                      </a:r>
                    </a:p>
                    <a:p>
                      <a:pPr algn="ctr" fontAlgn="b"/>
                      <a:r>
                        <a:rPr lang="en-GB" sz="16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ol</a:t>
                      </a:r>
                      <a:r>
                        <a:rPr lang="en-GB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</a:t>
                      </a:r>
                      <a:r>
                        <a:rPr lang="en-GB" sz="16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O m</a:t>
                      </a:r>
                      <a:r>
                        <a:rPr lang="en-GB" sz="16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2</a:t>
                      </a:r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s</a:t>
                      </a:r>
                      <a:r>
                        <a:rPr lang="en-GB" sz="16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3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W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.24±2.26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81.75±15.98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6±0.03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.17±0.98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713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gl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±0.51</a:t>
                      </a:r>
                      <a:r>
                        <a:rPr lang="en-US" altLang="zh-CN" sz="20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zh-CN" altLang="en-US" sz="16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8.22±18.25</a:t>
                      </a:r>
                      <a:r>
                        <a:rPr lang="en-US" altLang="zh-CN" sz="20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zh-CN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58±0.019</a:t>
                      </a:r>
                      <a:r>
                        <a:rPr lang="en-US" altLang="zh-CN" sz="20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zh-CN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2±0.39</a:t>
                      </a:r>
                      <a:r>
                        <a:rPr lang="en-US" altLang="zh-CN" sz="20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zh-CN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1600199" y="1396778"/>
            <a:ext cx="9372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of photosynthetic parameters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gl8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utant in comparison to the wild-typ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4235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78880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67</Words>
  <Application>Microsoft Office PowerPoint</Application>
  <PresentationFormat>宽屏</PresentationFormat>
  <Paragraphs>2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微软用户</cp:lastModifiedBy>
  <cp:revision>12</cp:revision>
  <dcterms:created xsi:type="dcterms:W3CDTF">2016-05-20T12:07:34Z</dcterms:created>
  <dcterms:modified xsi:type="dcterms:W3CDTF">2016-05-23T10:45:39Z</dcterms:modified>
</cp:coreProperties>
</file>